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315200" cy="960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142880" y="0"/>
            <a:ext cx="317052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306520" y="720360"/>
            <a:ext cx="2702160" cy="3600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1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12024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142880" y="9120240"/>
            <a:ext cx="317052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4E72D76-2255-4759-B0C0-B3703ED33F89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Rectangle 7"/>
          <p:cNvSpPr/>
          <p:nvPr/>
        </p:nvSpPr>
        <p:spPr>
          <a:xfrm>
            <a:off x="4143240" y="9120240"/>
            <a:ext cx="3170520" cy="47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D356EC3-D032-489E-9948-C2655EDB1063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1"/>
          <p:cNvSpPr>
            <a:spLocks noGrp="1"/>
          </p:cNvSpPr>
          <p:nvPr>
            <p:ph type="sldImg"/>
          </p:nvPr>
        </p:nvSpPr>
        <p:spPr>
          <a:xfrm>
            <a:off x="2308320" y="720720"/>
            <a:ext cx="2700360" cy="3600360"/>
          </a:xfrm>
          <a:prstGeom prst="rect">
            <a:avLst/>
          </a:prstGeom>
          <a:ln w="0">
            <a:noFill/>
          </a:ln>
        </p:spPr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19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EC1B62-E036-4865-A389-D2339336CDA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D1A2C0-720F-4858-9750-97BF8DC0C1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F0EF00-28CD-40ED-BC8A-1DB2EBA4F53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1CA7B4-F735-474A-8410-39DD93FC35E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A600AD-40B3-473B-8D6E-ACC48CE4B9A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5B01EE-6C1F-4CF9-A392-B4AC212445D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2F6696-BC0E-44F1-9F26-B3B9AC10FF4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07E82D-00A5-40E1-ACFD-D68EF967CB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55CFFB-1510-4EC3-B80E-CAB45392412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454C19-7A5F-4ADD-8386-1748B3BA4E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CFBC1B-D834-4CDF-8A9B-C362F4425D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23193E-C0C7-4815-8D77-BCE72A9E20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9EF6B9C-6E77-4D60-A746-566F0096D94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5" descr=""/>
          <p:cNvPicPr/>
          <p:nvPr/>
        </p:nvPicPr>
        <p:blipFill>
          <a:blip r:embed="rId1"/>
          <a:srcRect l="0" t="11998" r="0" b="8002"/>
          <a:stretch/>
        </p:blipFill>
        <p:spPr>
          <a:xfrm>
            <a:off x="0" y="3657600"/>
            <a:ext cx="6781680" cy="152388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6" descr=""/>
          <p:cNvPicPr/>
          <p:nvPr/>
        </p:nvPicPr>
        <p:blipFill>
          <a:blip r:embed="rId2"/>
          <a:srcRect l="0" t="15064" r="0" b="9624"/>
          <a:stretch/>
        </p:blipFill>
        <p:spPr>
          <a:xfrm>
            <a:off x="0" y="1981080"/>
            <a:ext cx="6858000" cy="1143000"/>
          </a:xfrm>
          <a:prstGeom prst="rect">
            <a:avLst/>
          </a:prstGeom>
          <a:ln w="0">
            <a:noFill/>
          </a:ln>
        </p:spPr>
      </p:pic>
      <p:sp>
        <p:nvSpPr>
          <p:cNvPr id="50" name="Text Box 7"/>
          <p:cNvSpPr/>
          <p:nvPr/>
        </p:nvSpPr>
        <p:spPr>
          <a:xfrm>
            <a:off x="48240" y="1706400"/>
            <a:ext cx="4958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.  Example of low diversity region on B73 RefGen_v1 chromosome 8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8"/>
          <p:cNvSpPr/>
          <p:nvPr/>
        </p:nvSpPr>
        <p:spPr>
          <a:xfrm>
            <a:off x="63360" y="3505320"/>
            <a:ext cx="4960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.  Example of B73-specific region on B73 RefGen_v1 chromosome 6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9"/>
          <p:cNvSpPr/>
          <p:nvPr/>
        </p:nvSpPr>
        <p:spPr>
          <a:xfrm>
            <a:off x="1222200" y="5105520"/>
            <a:ext cx="3934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be position (in MB) within chromosome 6 in the B73 RefGen_v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0"/>
          <p:cNvSpPr/>
          <p:nvPr/>
        </p:nvSpPr>
        <p:spPr>
          <a:xfrm>
            <a:off x="1163160" y="3048120"/>
            <a:ext cx="3934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be position (in MB) within chromosome 8 in the B73 RefGen_v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4" name="Group 13"/>
          <p:cNvGrpSpPr/>
          <p:nvPr/>
        </p:nvGrpSpPr>
        <p:grpSpPr>
          <a:xfrm>
            <a:off x="6171840" y="4648320"/>
            <a:ext cx="526680" cy="321840"/>
            <a:chOff x="6171840" y="4648320"/>
            <a:chExt cx="526680" cy="321840"/>
          </a:xfrm>
        </p:grpSpPr>
        <p:sp>
          <p:nvSpPr>
            <p:cNvPr id="55" name="Rectangle 12"/>
            <p:cNvSpPr/>
            <p:nvPr/>
          </p:nvSpPr>
          <p:spPr>
            <a:xfrm>
              <a:off x="6234120" y="4691160"/>
              <a:ext cx="39528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11"/>
            <p:cNvSpPr/>
            <p:nvPr/>
          </p:nvSpPr>
          <p:spPr>
            <a:xfrm>
              <a:off x="6171840" y="4648320"/>
              <a:ext cx="526680" cy="321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M&gt;B probes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M=B probes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&gt;M probes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7" name="Group 14"/>
          <p:cNvGrpSpPr/>
          <p:nvPr/>
        </p:nvGrpSpPr>
        <p:grpSpPr>
          <a:xfrm>
            <a:off x="6228720" y="2695680"/>
            <a:ext cx="526680" cy="321840"/>
            <a:chOff x="6228720" y="2695680"/>
            <a:chExt cx="526680" cy="321840"/>
          </a:xfrm>
        </p:grpSpPr>
        <p:sp>
          <p:nvSpPr>
            <p:cNvPr id="58" name="Rectangle 15"/>
            <p:cNvSpPr/>
            <p:nvPr/>
          </p:nvSpPr>
          <p:spPr>
            <a:xfrm>
              <a:off x="6291000" y="2738520"/>
              <a:ext cx="39492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16"/>
            <p:cNvSpPr/>
            <p:nvPr/>
          </p:nvSpPr>
          <p:spPr>
            <a:xfrm>
              <a:off x="6228720" y="2695680"/>
              <a:ext cx="526680" cy="321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M&gt;B probes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M=B probes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&gt;M probes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02T21:23:30Z</dcterms:created>
  <dc:creator>Nathan Springer</dc:creator>
  <dc:description/>
  <dc:language>en-US</dc:language>
  <cp:lastModifiedBy>acollings</cp:lastModifiedBy>
  <dcterms:modified xsi:type="dcterms:W3CDTF">2009-11-13T11:21:08Z</dcterms:modified>
  <cp:revision>28</cp:revision>
  <dc:subject/>
  <dc:title>Slide 1</dc:title>
</cp:coreProperties>
</file>